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16" d="100"/>
          <a:sy n="116" d="100"/>
        </p:scale>
        <p:origin x="8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318335208098989"/>
          <c:y val="8.3712784588441336E-2"/>
          <c:w val="0.8114710257991945"/>
          <c:h val="0.79661431112704606"/>
        </c:manualLayout>
      </c:layout>
      <c:lineChart>
        <c:grouping val="standard"/>
        <c:varyColors val="0"/>
        <c:ser>
          <c:idx val="0"/>
          <c:order val="0"/>
          <c:tx>
            <c:strRef>
              <c:f>Sheet1!$J$6</c:f>
              <c:strCache>
                <c:ptCount val="1"/>
                <c:pt idx="0">
                  <c:v>2022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I$7:$I$12</c:f>
              <c:strCache>
                <c:ptCount val="6"/>
                <c:pt idx="0">
                  <c:v>April</c:v>
                </c:pt>
                <c:pt idx="1">
                  <c:v>May</c:v>
                </c:pt>
                <c:pt idx="2">
                  <c:v>June</c:v>
                </c:pt>
                <c:pt idx="3">
                  <c:v>July</c:v>
                </c:pt>
                <c:pt idx="4">
                  <c:v>August</c:v>
                </c:pt>
                <c:pt idx="5">
                  <c:v>September</c:v>
                </c:pt>
              </c:strCache>
            </c:strRef>
          </c:cat>
          <c:val>
            <c:numRef>
              <c:f>Sheet1!$J$7:$J$12</c:f>
              <c:numCache>
                <c:formatCode>0</c:formatCode>
                <c:ptCount val="6"/>
                <c:pt idx="0">
                  <c:v>76.400000000000006</c:v>
                </c:pt>
                <c:pt idx="1">
                  <c:v>84.5</c:v>
                </c:pt>
                <c:pt idx="2">
                  <c:v>93.8</c:v>
                </c:pt>
                <c:pt idx="3">
                  <c:v>95.3</c:v>
                </c:pt>
                <c:pt idx="4">
                  <c:v>102.7</c:v>
                </c:pt>
                <c:pt idx="5">
                  <c:v>93.5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0-14AB-FF42-8E62-3ADD6F18882E}"/>
            </c:ext>
          </c:extLst>
        </c:ser>
        <c:ser>
          <c:idx val="1"/>
          <c:order val="1"/>
          <c:tx>
            <c:strRef>
              <c:f>Sheet1!$K$6</c:f>
              <c:strCache>
                <c:ptCount val="1"/>
                <c:pt idx="0">
                  <c:v>2023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I$7:$I$12</c:f>
              <c:strCache>
                <c:ptCount val="6"/>
                <c:pt idx="0">
                  <c:v>April</c:v>
                </c:pt>
                <c:pt idx="1">
                  <c:v>May</c:v>
                </c:pt>
                <c:pt idx="2">
                  <c:v>June</c:v>
                </c:pt>
                <c:pt idx="3">
                  <c:v>July</c:v>
                </c:pt>
                <c:pt idx="4">
                  <c:v>August</c:v>
                </c:pt>
                <c:pt idx="5">
                  <c:v>September</c:v>
                </c:pt>
              </c:strCache>
            </c:strRef>
          </c:cat>
          <c:val>
            <c:numRef>
              <c:f>Sheet1!$K$7:$K$12</c:f>
              <c:numCache>
                <c:formatCode>0</c:formatCode>
                <c:ptCount val="6"/>
                <c:pt idx="0">
                  <c:v>73.599999999999994</c:v>
                </c:pt>
                <c:pt idx="1">
                  <c:v>79.5</c:v>
                </c:pt>
                <c:pt idx="2">
                  <c:v>86.5</c:v>
                </c:pt>
                <c:pt idx="3">
                  <c:v>98.1</c:v>
                </c:pt>
                <c:pt idx="4">
                  <c:v>96.1</c:v>
                </c:pt>
                <c:pt idx="5">
                  <c:v>86.2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1-14AB-FF42-8E62-3ADD6F18882E}"/>
            </c:ext>
          </c:extLst>
        </c:ser>
        <c:ser>
          <c:idx val="2"/>
          <c:order val="2"/>
          <c:tx>
            <c:strRef>
              <c:f>Sheet1!$L$6</c:f>
              <c:strCache>
                <c:ptCount val="1"/>
                <c:pt idx="0">
                  <c:v>2024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star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star"/>
              <c:size val="7"/>
              <c:spPr>
                <a:noFill/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14AB-FF42-8E62-3ADD6F18882E}"/>
              </c:ext>
            </c:extLst>
          </c:dPt>
          <c:cat>
            <c:strRef>
              <c:f>Sheet1!$I$7:$I$12</c:f>
              <c:strCache>
                <c:ptCount val="6"/>
                <c:pt idx="0">
                  <c:v>April</c:v>
                </c:pt>
                <c:pt idx="1">
                  <c:v>May</c:v>
                </c:pt>
                <c:pt idx="2">
                  <c:v>June</c:v>
                </c:pt>
                <c:pt idx="3">
                  <c:v>July</c:v>
                </c:pt>
                <c:pt idx="4">
                  <c:v>August</c:v>
                </c:pt>
                <c:pt idx="5">
                  <c:v>September</c:v>
                </c:pt>
              </c:strCache>
            </c:strRef>
          </c:cat>
          <c:val>
            <c:numRef>
              <c:f>Sheet1!$L$7:$L$12</c:f>
              <c:numCache>
                <c:formatCode>0</c:formatCode>
                <c:ptCount val="6"/>
                <c:pt idx="0">
                  <c:v>73.8</c:v>
                </c:pt>
                <c:pt idx="1">
                  <c:v>83.2</c:v>
                </c:pt>
                <c:pt idx="2">
                  <c:v>98.1</c:v>
                </c:pt>
                <c:pt idx="3">
                  <c:v>101</c:v>
                </c:pt>
                <c:pt idx="4">
                  <c:v>94.4</c:v>
                </c:pt>
                <c:pt idx="5">
                  <c:v>92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14AB-FF42-8E62-3ADD6F1888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52403248"/>
        <c:axId val="852404960"/>
      </c:lineChart>
      <c:catAx>
        <c:axId val="852403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52404960"/>
        <c:crosses val="autoZero"/>
        <c:auto val="1"/>
        <c:lblAlgn val="ctr"/>
        <c:lblOffset val="100"/>
        <c:noMultiLvlLbl val="0"/>
      </c:catAx>
      <c:valAx>
        <c:axId val="852404960"/>
        <c:scaling>
          <c:orientation val="minMax"/>
          <c:max val="105"/>
          <c:min val="7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Average monthly temperature</a:t>
                </a:r>
                <a:r>
                  <a:rPr lang="en-US" baseline="0"/>
                  <a:t> (F)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3.1846946551035947E-2"/>
              <c:y val="0.209322779486189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5240324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22825773794404733"/>
          <c:y val="0.16929464815146794"/>
          <c:w val="0.14685559170629345"/>
          <c:h val="0.237013425269893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2BDBA8-C208-F9B9-C5F8-58941B10FB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5E0D887-8FD6-7A34-E763-63B85DB38E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16871C-691C-DA74-C3E9-1630F36BD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7AAC32-B468-0B4F-0C73-562B6F510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2E3AFB-A71F-1DEC-3914-13ADA16EE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986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8471AC-DFC3-FBB5-0DF8-EF4F6D9088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3B01E3-2AA7-5336-5E8F-25853360C2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39DF42-00AA-97BC-E2A2-3FCCB2E00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06A3B6-BDE8-A4ED-3E1B-084488DB5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1AA062-4185-57DA-8567-300122DBC0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287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1E3834-ED3D-4C72-C98F-16EEBEBAE9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9E55D4-E2B2-E365-C2A4-14AADA2B22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6FD81B-DF95-F317-8FC5-74A306517D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18F8DE-451E-5FC0-0411-E661591B6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0F7A4A-2EA5-1E20-370E-72E5B41AC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8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B06EC6-FFD6-E911-F578-BA725615AC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296634-F484-1AF9-CCED-D11A6AD725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91402F-23EF-E4C8-EC71-EA765B390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65FEA9-7077-559A-267D-F99ACD55F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FC137B-EBEB-B69D-BC3F-1F4348AF0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63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F23E2A-0049-CFED-20A2-573B03D684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809B6C-493B-FD1F-7228-040F9F5076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73A4A4-B046-D217-89BC-A4B18F28C1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41985B-3C5F-F300-028C-7EB6FA5AA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6C8DEA-CF92-18A2-5EE7-72BEA3301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759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892720-CC8D-4202-3298-FF98E1E0E5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BFB3B8-9620-8D4B-6546-9DCF96CC43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F915E1-7891-C21E-7876-0D5ABBC42C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B61AA3-A696-D41D-A82E-7CF8FB4AF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09C969-CAE7-E50D-7F18-4D2193BDF5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3843A9-024D-FF9C-13E7-89E96E2CF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347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5F10EC-8A09-3079-E236-943AE173EC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354FCD-FE0D-A4AB-ABE4-03F517E3C7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71B97C-4098-0309-E862-A36F007D5D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676AD19-0F69-E061-3A83-D585CFBE94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B99365C-4FEB-57FD-6E65-EF98944087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299BF0E-1409-61CE-6514-15CACF15B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246A66F-5387-BBA7-B384-4C4A2517E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2A852C7-A8FA-6F8E-61D6-7EE98CF54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418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571BDE-5B02-D376-3BA8-EE43B2E54F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96F531C-21D9-53FC-C854-D9C7843FA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4D80BC-C82B-0268-459F-01650127C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1F40E2-1792-D414-267B-D31BC637F8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502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1FE4B3-4A02-1BD3-212E-F4B802B54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FCB167-8B67-873E-1ECD-EC9D611128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A64825-F99B-4906-C90B-AC7182F94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400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85B6DD-CD51-3023-EF2E-4317EF3923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FECF81-017C-A11E-89A8-34EB4825F7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B59A07-0C8B-1A46-2B80-25C34632F5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114038-DD3A-3891-E1DC-602E344F2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A2A102-9006-07B4-7ABB-BB2FBA38C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9D7E46-2BF6-0399-7699-C481A070C0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931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C68EC1-C231-904C-58D8-E6426AD35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EC8B43-DC76-161B-3AC4-ECDC4514AA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6DCA74-4458-3E9E-4D7E-E95CFC0FB8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A1568A-1374-3C49-6688-7EF909AA1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0751EC-9BF5-C3A4-F444-BA47606BB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A84512-A727-2F5B-1828-3B7DE31E1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459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46B23B3-9CA3-993B-E445-BE27F809FE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8054A6-D22E-C3C4-3B17-662C6D2147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819B47-4C37-DA2D-324B-94B12153AA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833C25B-8B8F-8641-BDEB-FAE4F3D2823B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70B76E-7E61-242A-45D9-85505C4570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6A81F9-3508-DA4A-9CD3-FD639024EF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32F245-C593-5A45-8AD7-671E8C24A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509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weather.gov/wrh/climate" TargetMode="Externa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53C13B55-B45E-E0C1-36A8-C4FF6F82F55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59712654"/>
              </p:ext>
            </p:extLst>
          </p:nvPr>
        </p:nvGraphicFramePr>
        <p:xfrm>
          <a:off x="3110429" y="1164382"/>
          <a:ext cx="5971142" cy="41787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267947ED-54DD-6BBB-5CD0-2D6BA7E63255}"/>
              </a:ext>
            </a:extLst>
          </p:cNvPr>
          <p:cNvSpPr txBox="1"/>
          <p:nvPr/>
        </p:nvSpPr>
        <p:spPr>
          <a:xfrm>
            <a:off x="3219906" y="5343180"/>
            <a:ext cx="6487766" cy="11440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buNone/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2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verage monthly maximum temperature of Stockton, CA, representing the northern San Joaquin Valley weather, from 2022-2024. The data was retrieved from the National Weather Service website,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www.weather.gov/wrh/climate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6990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2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halendra P Rijal</dc:creator>
  <cp:lastModifiedBy>Jhalendra P Rijal</cp:lastModifiedBy>
  <cp:revision>3</cp:revision>
  <dcterms:created xsi:type="dcterms:W3CDTF">2026-02-18T23:04:14Z</dcterms:created>
  <dcterms:modified xsi:type="dcterms:W3CDTF">2026-02-19T00:06:26Z</dcterms:modified>
</cp:coreProperties>
</file>